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"/>
  </p:notesMasterIdLst>
  <p:sldIdLst>
    <p:sldId id="300" r:id="rId2"/>
    <p:sldId id="285" r:id="rId3"/>
    <p:sldId id="286" r:id="rId4"/>
    <p:sldId id="287" r:id="rId5"/>
    <p:sldId id="288" r:id="rId6"/>
    <p:sldId id="289" r:id="rId7"/>
    <p:sldId id="290" r:id="rId8"/>
    <p:sldId id="291" r:id="rId9"/>
    <p:sldId id="292" r:id="rId10"/>
    <p:sldId id="293" r:id="rId11"/>
    <p:sldId id="294" r:id="rId12"/>
    <p:sldId id="295" r:id="rId13"/>
    <p:sldId id="296" r:id="rId14"/>
    <p:sldId id="297" r:id="rId15"/>
    <p:sldId id="298" r:id="rId16"/>
    <p:sldId id="299" r:id="rId17"/>
  </p:sldIdLst>
  <p:sldSz cx="6858000" cy="9906000" type="A4"/>
  <p:notesSz cx="6858000" cy="9144000"/>
  <p:defaultTextStyle>
    <a:defPPr>
      <a:defRPr lang="de-DE"/>
    </a:defPPr>
    <a:lvl1pPr marL="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638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277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09162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4555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8193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1832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54711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91098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36" autoAdjust="0"/>
    <p:restoredTop sz="94660"/>
  </p:normalViewPr>
  <p:slideViewPr>
    <p:cSldViewPr>
      <p:cViewPr varScale="1">
        <p:scale>
          <a:sx n="64" d="100"/>
          <a:sy n="64" d="100"/>
        </p:scale>
        <p:origin x="2295" y="51"/>
      </p:cViewPr>
      <p:guideLst>
        <p:guide orient="horz" pos="3120"/>
        <p:guide pos="2160"/>
      </p:guideLst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325E34-DA52-4EF1-BB87-4E2A84138020}" type="datetimeFigureOut">
              <a:rPr lang="zh-CN" altLang="en-US" smtClean="0"/>
              <a:pPr/>
              <a:t>2026/2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1130FD-5ED1-4537-99E7-245B2771744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64469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63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2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09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455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81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18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54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910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1" y="396703"/>
            <a:ext cx="1543050" cy="845220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4" y="6365525"/>
            <a:ext cx="5829300" cy="1967440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4" y="4198588"/>
            <a:ext cx="5829300" cy="2166937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3638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277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0916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45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8193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183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5471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29109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1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9"/>
            <a:ext cx="3030141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9"/>
            <a:ext cx="3031332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3700"/>
            </a:lvl1pPr>
            <a:lvl2pPr>
              <a:defRPr sz="33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7"/>
            <a:ext cx="2256235" cy="67759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700"/>
            </a:lvl1pPr>
            <a:lvl2pPr marL="536387" indent="0">
              <a:buNone/>
              <a:defRPr sz="3300"/>
            </a:lvl2pPr>
            <a:lvl3pPr marL="1072775" indent="0">
              <a:buNone/>
              <a:defRPr sz="2800"/>
            </a:lvl3pPr>
            <a:lvl4pPr marL="1609162" indent="0">
              <a:buNone/>
              <a:defRPr sz="2400"/>
            </a:lvl4pPr>
            <a:lvl5pPr marL="2145550" indent="0">
              <a:buNone/>
              <a:defRPr sz="2400"/>
            </a:lvl5pPr>
            <a:lvl6pPr marL="2681937" indent="0">
              <a:buNone/>
              <a:defRPr sz="2400"/>
            </a:lvl6pPr>
            <a:lvl7pPr marL="3218325" indent="0">
              <a:buNone/>
              <a:defRPr sz="2400"/>
            </a:lvl7pPr>
            <a:lvl8pPr marL="3754711" indent="0">
              <a:buNone/>
              <a:defRPr sz="2400"/>
            </a:lvl8pPr>
            <a:lvl9pPr marL="4291098" indent="0">
              <a:buNone/>
              <a:defRPr sz="24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1" y="396701"/>
            <a:ext cx="6172200" cy="1651000"/>
          </a:xfrm>
          <a:prstGeom prst="rect">
            <a:avLst/>
          </a:prstGeom>
        </p:spPr>
        <p:txBody>
          <a:bodyPr vert="horz" lIns="107278" tIns="53638" rIns="107278" bIns="53638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2"/>
          </a:xfrm>
          <a:prstGeom prst="rect">
            <a:avLst/>
          </a:prstGeom>
        </p:spPr>
        <p:txBody>
          <a:bodyPr vert="horz" lIns="107278" tIns="53638" rIns="107278" bIns="53638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24.02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2775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2291" indent="-402291" algn="l" defTabSz="1072775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71629" indent="-335242" algn="l" defTabSz="1072775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096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77356" indent="-268193" algn="l" defTabSz="1072775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13743" indent="-268193" algn="l" defTabSz="1072775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50130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48651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22905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559293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638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277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9162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4555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193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1832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54711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91098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9BD9079-A76B-D6A7-D5A7-A7DBBE96DD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A6BB1F5-3D72-6FD9-2E0A-5BB4950C6040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364369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E95F99F-B11F-34F9-9D3B-0990C767ADF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8E17443-ADB1-8D2B-6C32-B8273F76D6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805C0C5-681E-AC59-6272-EA9C14BB8D1C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10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5834363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AA659F-B9D2-E194-7E81-D74B9FD0BE0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DE36EEE-3B12-421E-6F25-B63A70FFEB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AE80B62-9AF3-FF4E-817E-5151620B5246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1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2426961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C09008-08A5-2C0F-52D6-B98543CA67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DBC7CFE-4309-99B1-B3D8-6F729D6DB1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E7B7643-B934-022D-C986-7D6E7CE3D845}"/>
              </a:ext>
            </a:extLst>
          </p:cNvPr>
          <p:cNvSpPr txBox="1"/>
          <p:nvPr/>
        </p:nvSpPr>
        <p:spPr>
          <a:xfrm>
            <a:off x="1772816" y="9146014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1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7435849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7F0236-862D-FEE9-DDD3-81600566B0E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5ACB577-618A-3811-C1C0-E05BBDAFA9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F118B0C-8882-CE58-6E44-09E5CF59DB82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1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0149312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4A40F1F-82E1-0984-9DE2-3EFCB39FD9C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7449373-1A43-0C6B-5BB2-5B209BBA64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1B28E7F-3C17-FFDE-059A-70A4E099ACD9}"/>
              </a:ext>
            </a:extLst>
          </p:cNvPr>
          <p:cNvSpPr txBox="1"/>
          <p:nvPr/>
        </p:nvSpPr>
        <p:spPr>
          <a:xfrm>
            <a:off x="1772816" y="9146014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1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055539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E1D8AC5-E647-D65E-4D87-21DFE5FC67F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44F5A03-0455-EE3F-8378-17633C4923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0394F7B-78FE-AC16-9CD8-72850C61669F}"/>
              </a:ext>
            </a:extLst>
          </p:cNvPr>
          <p:cNvSpPr txBox="1"/>
          <p:nvPr/>
        </p:nvSpPr>
        <p:spPr>
          <a:xfrm>
            <a:off x="1772816" y="9146014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15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410309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C68ACB-7BED-F794-0FC1-BEA7D90712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7327E9A-62FA-BBA0-616D-5DF6310C30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901864B-97A8-913F-255A-B5E8AC98A36B}"/>
              </a:ext>
            </a:extLst>
          </p:cNvPr>
          <p:cNvSpPr txBox="1"/>
          <p:nvPr/>
        </p:nvSpPr>
        <p:spPr>
          <a:xfrm>
            <a:off x="1772816" y="9146014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1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312967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F85F08D-4D48-850C-8F0A-2839B07A9C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D3A5462-2717-0AF9-F0CB-7386A970022C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888556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00B35B7-DF2A-5BE0-1E65-59C2D1A788D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5D9F55E-DF47-01A0-FCB3-1D69667F99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EE5CD42-C10A-A9E5-B2E3-D158E87E91C7}"/>
              </a:ext>
            </a:extLst>
          </p:cNvPr>
          <p:cNvSpPr txBox="1"/>
          <p:nvPr/>
        </p:nvSpPr>
        <p:spPr>
          <a:xfrm>
            <a:off x="1772816" y="9362038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037871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9D15228-DB80-345F-E7CC-FD91AAE0FBB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0FE3F1F-F541-1CC2-BF6D-F1188D32AB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F156895-D9F8-6675-207D-287FB93153D5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001657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C03DF0-B00D-2046-6A5A-864285DEDA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B8B3E0D-11D7-328A-1B80-A2603632B9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D6B6933-5BB1-B733-22C0-0D0A3212278C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5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277941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10A4598-D9A0-0ED6-2BE7-CEDC2BE980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99A421B-36DF-A768-F680-E030516BC1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1F1EFBB-57D6-B7AE-1236-F58DA79F461E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740016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C94B21-699C-4184-7290-A2E4213C874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7EC43D1-8F13-8CCF-1E8B-617063430E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788419B-D936-2E67-77C0-92F523876EF7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7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547469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EE51006-108E-2C08-D063-F4651C871E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5B8B58B-5326-AF8F-EED6-806C591EA8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2682B41-7ECF-B38F-4147-202CB3B0F209}"/>
              </a:ext>
            </a:extLst>
          </p:cNvPr>
          <p:cNvSpPr txBox="1"/>
          <p:nvPr/>
        </p:nvSpPr>
        <p:spPr>
          <a:xfrm>
            <a:off x="1772816" y="9273480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943422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4FB742-D8ED-230E-7FAD-6749409CAE0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825C0E7-9495-75DB-3247-B522FEEF62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79"/>
            <a:ext cx="6858000" cy="969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1E68CA9-8239-5FEB-6F51-C0C37A7ED250}"/>
              </a:ext>
            </a:extLst>
          </p:cNvPr>
          <p:cNvSpPr txBox="1"/>
          <p:nvPr/>
        </p:nvSpPr>
        <p:spPr>
          <a:xfrm>
            <a:off x="1772816" y="8841432"/>
            <a:ext cx="34563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upplementary Figure S9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1287732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</TotalTime>
  <Words>48</Words>
  <Application>Microsoft Office PowerPoint</Application>
  <PresentationFormat>A4 纸张(210x297 毫米)</PresentationFormat>
  <Paragraphs>16</Paragraphs>
  <Slides>1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19" baseType="lpstr">
      <vt:lpstr>Arial</vt:lpstr>
      <vt:lpstr>Calibri</vt:lpstr>
      <vt:lpstr>Larissa-Design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ng, Bohai</dc:creator>
  <cp:lastModifiedBy>apple</cp:lastModifiedBy>
  <cp:revision>597</cp:revision>
  <dcterms:created xsi:type="dcterms:W3CDTF">2019-03-24T15:08:43Z</dcterms:created>
  <dcterms:modified xsi:type="dcterms:W3CDTF">2026-02-24T01:29:49Z</dcterms:modified>
</cp:coreProperties>
</file>